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83" r:id="rId2"/>
    <p:sldId id="267" r:id="rId3"/>
    <p:sldId id="284" r:id="rId4"/>
    <p:sldId id="258" r:id="rId5"/>
    <p:sldId id="281" r:id="rId6"/>
    <p:sldId id="276" r:id="rId7"/>
    <p:sldId id="277" r:id="rId8"/>
    <p:sldId id="285" r:id="rId9"/>
    <p:sldId id="271" r:id="rId10"/>
    <p:sldId id="282" r:id="rId11"/>
    <p:sldId id="288" r:id="rId1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ud, Dan" initials="MD" lastIdx="4" clrIdx="0">
    <p:extLst>
      <p:ext uri="{19B8F6BF-5375-455C-9EA6-DF929625EA0E}">
        <p15:presenceInfo xmlns:p15="http://schemas.microsoft.com/office/powerpoint/2012/main" userId="S::dmichaud@ad.unc.edu::1745654c-474c-4ec2-937e-32aa9b07e56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AAD4F0-6F89-484F-AD3A-57E0CCA06278}" v="5" dt="2021-11-22T16:08:36.972"/>
    <p1510:client id="{74417668-A62A-463F-960B-E236193E713E}" v="313" dt="2021-11-19T21:06:12.959"/>
    <p1510:client id="{F8987137-E780-4966-BC94-6CA4821D5F4C}" v="11" dt="2021-12-17T18:41:32.1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70" autoAdjust="0"/>
    <p:restoredTop sz="96400" autoAdjust="0"/>
  </p:normalViewPr>
  <p:slideViewPr>
    <p:cSldViewPr snapToGrid="0">
      <p:cViewPr varScale="1">
        <p:scale>
          <a:sx n="58" d="100"/>
          <a:sy n="58" d="100"/>
        </p:scale>
        <p:origin x="215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7" Type="http://schemas.openxmlformats.org/officeDocument/2006/relationships/image" Target="../media/image23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Relationship Id="rId6" Type="http://schemas.openxmlformats.org/officeDocument/2006/relationships/image" Target="../media/image22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image" Target="../media/image38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8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2" Type="http://schemas.openxmlformats.org/officeDocument/2006/relationships/image" Target="../media/image51.emf"/><Relationship Id="rId1" Type="http://schemas.openxmlformats.org/officeDocument/2006/relationships/image" Target="../media/image50.emf"/><Relationship Id="rId6" Type="http://schemas.openxmlformats.org/officeDocument/2006/relationships/image" Target="../media/image55.emf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0A7A3507-1DCC-4508-A126-A8A4E4CEEBE1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AFEB4AE0-110C-4463-8F30-6EDFE0E5F1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408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685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615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308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569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34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480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288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770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55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915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337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452758-4AF0-43FA-9201-17879AEF3242}" type="datetimeFigureOut">
              <a:rPr lang="en-US" smtClean="0"/>
              <a:t>12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A7A56-8E86-401F-889B-F455BC82A6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69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5" Type="http://schemas.openxmlformats.org/officeDocument/2006/relationships/image" Target="../media/image48.emf"/><Relationship Id="rId4" Type="http://schemas.openxmlformats.org/officeDocument/2006/relationships/oleObject" Target="../embeddings/oleObject30.bin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emf"/><Relationship Id="rId13" Type="http://schemas.openxmlformats.org/officeDocument/2006/relationships/oleObject" Target="../embeddings/oleObject36.bin"/><Relationship Id="rId3" Type="http://schemas.openxmlformats.org/officeDocument/2006/relationships/oleObject" Target="../embeddings/oleObject31.bin"/><Relationship Id="rId7" Type="http://schemas.openxmlformats.org/officeDocument/2006/relationships/oleObject" Target="../embeddings/oleObject33.bin"/><Relationship Id="rId12" Type="http://schemas.openxmlformats.org/officeDocument/2006/relationships/image" Target="../media/image5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51.emf"/><Relationship Id="rId11" Type="http://schemas.openxmlformats.org/officeDocument/2006/relationships/oleObject" Target="../embeddings/oleObject35.bin"/><Relationship Id="rId5" Type="http://schemas.openxmlformats.org/officeDocument/2006/relationships/oleObject" Target="../embeddings/oleObject32.bin"/><Relationship Id="rId10" Type="http://schemas.openxmlformats.org/officeDocument/2006/relationships/image" Target="../media/image53.emf"/><Relationship Id="rId4" Type="http://schemas.openxmlformats.org/officeDocument/2006/relationships/image" Target="../media/image50.emf"/><Relationship Id="rId9" Type="http://schemas.openxmlformats.org/officeDocument/2006/relationships/oleObject" Target="../embeddings/oleObject34.bin"/><Relationship Id="rId14" Type="http://schemas.openxmlformats.org/officeDocument/2006/relationships/image" Target="../media/image55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14.png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png"/><Relationship Id="rId5" Type="http://schemas.openxmlformats.org/officeDocument/2006/relationships/image" Target="../media/image12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13" Type="http://schemas.openxmlformats.org/officeDocument/2006/relationships/oleObject" Target="../embeddings/oleObject11.bin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12" Type="http://schemas.openxmlformats.org/officeDocument/2006/relationships/image" Target="../media/image21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3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0.bin"/><Relationship Id="rId5" Type="http://schemas.openxmlformats.org/officeDocument/2006/relationships/oleObject" Target="../embeddings/oleObject7.bin"/><Relationship Id="rId15" Type="http://schemas.openxmlformats.org/officeDocument/2006/relationships/oleObject" Target="../embeddings/oleObject12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9.bin"/><Relationship Id="rId14" Type="http://schemas.openxmlformats.org/officeDocument/2006/relationships/image" Target="../media/image22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oleObject" Target="../embeddings/oleObject18.bin"/><Relationship Id="rId3" Type="http://schemas.openxmlformats.org/officeDocument/2006/relationships/oleObject" Target="../embeddings/oleObject13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28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0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25.emf"/><Relationship Id="rId11" Type="http://schemas.openxmlformats.org/officeDocument/2006/relationships/oleObject" Target="../embeddings/oleObject17.bin"/><Relationship Id="rId5" Type="http://schemas.openxmlformats.org/officeDocument/2006/relationships/oleObject" Target="../embeddings/oleObject14.bin"/><Relationship Id="rId15" Type="http://schemas.openxmlformats.org/officeDocument/2006/relationships/oleObject" Target="../embeddings/oleObject19.bin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29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13" Type="http://schemas.openxmlformats.org/officeDocument/2006/relationships/oleObject" Target="../embeddings/oleObject25.bin"/><Relationship Id="rId3" Type="http://schemas.openxmlformats.org/officeDocument/2006/relationships/oleObject" Target="../embeddings/oleObject20.bin"/><Relationship Id="rId7" Type="http://schemas.openxmlformats.org/officeDocument/2006/relationships/oleObject" Target="../embeddings/oleObject22.bin"/><Relationship Id="rId12" Type="http://schemas.openxmlformats.org/officeDocument/2006/relationships/image" Target="../media/image3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7.emf"/><Relationship Id="rId1" Type="http://schemas.openxmlformats.org/officeDocument/2006/relationships/vmlDrawing" Target="../drawings/vmlDrawing6.vml"/><Relationship Id="rId6" Type="http://schemas.openxmlformats.org/officeDocument/2006/relationships/image" Target="../media/image32.emf"/><Relationship Id="rId11" Type="http://schemas.openxmlformats.org/officeDocument/2006/relationships/oleObject" Target="../embeddings/oleObject24.bin"/><Relationship Id="rId5" Type="http://schemas.openxmlformats.org/officeDocument/2006/relationships/oleObject" Target="../embeddings/oleObject21.bin"/><Relationship Id="rId15" Type="http://schemas.openxmlformats.org/officeDocument/2006/relationships/oleObject" Target="../embeddings/oleObject26.bin"/><Relationship Id="rId10" Type="http://schemas.openxmlformats.org/officeDocument/2006/relationships/image" Target="../media/image34.emf"/><Relationship Id="rId4" Type="http://schemas.openxmlformats.org/officeDocument/2006/relationships/image" Target="../media/image31.emf"/><Relationship Id="rId9" Type="http://schemas.openxmlformats.org/officeDocument/2006/relationships/oleObject" Target="../embeddings/oleObject23.bin"/><Relationship Id="rId14" Type="http://schemas.openxmlformats.org/officeDocument/2006/relationships/image" Target="../media/image36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oleObject" Target="../embeddings/oleObject27.bin"/><Relationship Id="rId7" Type="http://schemas.openxmlformats.org/officeDocument/2006/relationships/oleObject" Target="../embeddings/oleObject2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9.emf"/><Relationship Id="rId5" Type="http://schemas.openxmlformats.org/officeDocument/2006/relationships/oleObject" Target="../embeddings/oleObject28.bin"/><Relationship Id="rId4" Type="http://schemas.openxmlformats.org/officeDocument/2006/relationships/image" Target="../media/image38.emf"/><Relationship Id="rId9" Type="http://schemas.openxmlformats.org/officeDocument/2006/relationships/image" Target="../media/image41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/><Relationship Id="rId7" Type="http://schemas.openxmlformats.org/officeDocument/2006/relationships/image" Target="../media/image47.png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6.png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95B854F-0DF7-475C-A086-E4AD226562DD}"/>
              </a:ext>
            </a:extLst>
          </p:cNvPr>
          <p:cNvSpPr txBox="1"/>
          <p:nvPr/>
        </p:nvSpPr>
        <p:spPr>
          <a:xfrm>
            <a:off x="245125" y="7995076"/>
            <a:ext cx="63677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plots pertaining to data in Figure 1.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 and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12a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bi3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dTomato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D1d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21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 cells stimulated with indicated conditions corresponding to Figure 1F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B.) Quantification of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baseline="300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dTomato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 cells from (A). C)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presentative flow cytometry plots for data in figures 1H, 1I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66AEB8C-9863-4B6B-A98B-AEF05C8A43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1947" y="3260180"/>
            <a:ext cx="6485738" cy="15325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C2384D9-A120-464F-BFD9-932CEC0FE9A9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7D70A5-24A3-400C-B6D8-F0034F5BECB4}"/>
              </a:ext>
            </a:extLst>
          </p:cNvPr>
          <p:cNvSpPr txBox="1"/>
          <p:nvPr/>
        </p:nvSpPr>
        <p:spPr>
          <a:xfrm>
            <a:off x="198304" y="2983181"/>
            <a:ext cx="37457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41F17D9-331E-486A-BCCE-032E403DD1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0704" y="687259"/>
            <a:ext cx="3503822" cy="207400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3329D00-5091-483B-8588-6DD81371FBAB}"/>
              </a:ext>
            </a:extLst>
          </p:cNvPr>
          <p:cNvSpPr txBox="1"/>
          <p:nvPr/>
        </p:nvSpPr>
        <p:spPr>
          <a:xfrm>
            <a:off x="245125" y="1078858"/>
            <a:ext cx="9555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1d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5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21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E897A19-A862-4E61-837E-1D8E46A23D5C}"/>
              </a:ext>
            </a:extLst>
          </p:cNvPr>
          <p:cNvSpPr txBox="1"/>
          <p:nvPr/>
        </p:nvSpPr>
        <p:spPr>
          <a:xfrm>
            <a:off x="245125" y="1920060"/>
            <a:ext cx="9555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Il12a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Ebi3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Tom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1d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5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D21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67C5FA6-8C6E-41D5-9291-F22FB4E5749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57109"/>
              </p:ext>
            </p:extLst>
          </p:nvPr>
        </p:nvGraphicFramePr>
        <p:xfrm>
          <a:off x="4932595" y="692928"/>
          <a:ext cx="1367856" cy="23177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9" r:id="rId5" imgW="3216732" imgH="5450571" progId="Prism9.Document">
                  <p:embed/>
                </p:oleObj>
              </mc:Choice>
              <mc:Fallback>
                <p:oleObj name="Prism 9" r:id="rId5" imgW="3216732" imgH="5450571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B67C5FA6-8C6E-41D5-9291-F22FB4E5749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32595" y="692928"/>
                        <a:ext cx="1367856" cy="23177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EF7A56C5-8ACC-4B22-B213-AF1F200433C5}"/>
              </a:ext>
            </a:extLst>
          </p:cNvPr>
          <p:cNvSpPr txBox="1"/>
          <p:nvPr/>
        </p:nvSpPr>
        <p:spPr>
          <a:xfrm>
            <a:off x="4746113" y="539942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8106518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6695F513-5D56-42F5-879A-4A23FDA10D4B}"/>
              </a:ext>
            </a:extLst>
          </p:cNvPr>
          <p:cNvGrpSpPr/>
          <p:nvPr/>
        </p:nvGrpSpPr>
        <p:grpSpPr>
          <a:xfrm>
            <a:off x="400721" y="918057"/>
            <a:ext cx="6317138" cy="2543501"/>
            <a:chOff x="485085" y="4568997"/>
            <a:chExt cx="6317138" cy="254350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0E03FD9-2CA4-4252-B0DB-80655650BE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30039"/>
            <a:stretch/>
          </p:blipFill>
          <p:spPr>
            <a:xfrm>
              <a:off x="485085" y="4568997"/>
              <a:ext cx="2631783" cy="2543501"/>
            </a:xfrm>
            <a:prstGeom prst="rect">
              <a:avLst/>
            </a:prstGeom>
          </p:spPr>
        </p:pic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8153EA8A-749B-41B9-B638-779518EBDD7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040668" y="4568997"/>
            <a:ext cx="3761555" cy="254350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3558" name="Prism 9" r:id="rId4" imgW="6339109" imgH="4285833" progId="Prism9.Document">
                    <p:embed/>
                  </p:oleObj>
                </mc:Choice>
                <mc:Fallback>
                  <p:oleObj name="Prism 9" r:id="rId4" imgW="6339109" imgH="4285833" progId="Prism9.Document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8153EA8A-749B-41B9-B638-779518EBDD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040668" y="4568997"/>
                          <a:ext cx="3761555" cy="254350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83DB340F-E5FA-4DBF-9DE9-54DC66065EFC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C676D96-B7BD-43EE-B3DE-10D2DA1A8865}"/>
              </a:ext>
            </a:extLst>
          </p:cNvPr>
          <p:cNvSpPr txBox="1"/>
          <p:nvPr/>
        </p:nvSpPr>
        <p:spPr>
          <a:xfrm>
            <a:off x="1340763" y="723657"/>
            <a:ext cx="126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4D66FF5-3C3A-4B9B-8D1A-0701FF806B95}"/>
              </a:ext>
            </a:extLst>
          </p:cNvPr>
          <p:cNvSpPr txBox="1"/>
          <p:nvPr/>
        </p:nvSpPr>
        <p:spPr>
          <a:xfrm>
            <a:off x="3876020" y="723657"/>
            <a:ext cx="12678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D21D0B-12B4-4CA0-BC29-41D914B5E797}"/>
              </a:ext>
            </a:extLst>
          </p:cNvPr>
          <p:cNvSpPr txBox="1"/>
          <p:nvPr/>
        </p:nvSpPr>
        <p:spPr>
          <a:xfrm>
            <a:off x="245125" y="7995076"/>
            <a:ext cx="6367749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</a:t>
            </a:r>
            <a:r>
              <a:rPr lang="en-US" sz="1200" b="1" dirty="0">
                <a:latin typeface="Times New Roman"/>
                <a:ea typeface="Times New Roman" panose="02020603050405020304" pitchFamily="18" charset="0"/>
                <a:cs typeface="Times New Roman"/>
              </a:rPr>
              <a:t>10</a:t>
            </a: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Extended CRT0066101 tumor study data. A) Frequencies of indicated CD19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subsets isolated from spleens (left) and tumors (right) from vehicle and CRT0066101 treated mice.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16804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35E1F04-47DB-40CF-BF69-335761878B2E}"/>
              </a:ext>
            </a:extLst>
          </p:cNvPr>
          <p:cNvSpPr txBox="1"/>
          <p:nvPr/>
        </p:nvSpPr>
        <p:spPr>
          <a:xfrm>
            <a:off x="245125" y="7995076"/>
            <a:ext cx="6367749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</a:t>
            </a:r>
            <a:r>
              <a:rPr lang="en-US" sz="1200" b="1" dirty="0">
                <a:latin typeface="Times New Roman"/>
                <a:ea typeface="Times New Roman" panose="02020603050405020304" pitchFamily="18" charset="0"/>
                <a:cs typeface="Times New Roman"/>
              </a:rPr>
              <a:t>11</a:t>
            </a: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Effect of PKD2 function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on other IL-12 family cytokines and  immunosuppressive effector proteins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A) Relative expression of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Il27a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and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Il12b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in CD1d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Hi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CD21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Hi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CD5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WT and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rkd2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-S707A/S711A B cells stimulated for 48 hours with indicated stimuli. N=3. B) Relative expression of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Il10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,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Tgfb1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,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dcd1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, and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dcd1l1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in CD1d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Hi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CD21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Hi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CD5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WT and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rkd2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-S707A/S711A B cells stimulated for 48 hours with indicated stimuli. N=3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3FBD20-DC36-463E-90C3-05A538D101DF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FBD7AD4-3F7E-49AA-872F-90205A890CE3}"/>
              </a:ext>
            </a:extLst>
          </p:cNvPr>
          <p:cNvSpPr txBox="1"/>
          <p:nvPr/>
        </p:nvSpPr>
        <p:spPr>
          <a:xfrm>
            <a:off x="198304" y="28213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F14EA5C-B55A-49BE-99D3-6F79B58A7D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6560641"/>
              </p:ext>
            </p:extLst>
          </p:nvPr>
        </p:nvGraphicFramePr>
        <p:xfrm>
          <a:off x="422275" y="3252802"/>
          <a:ext cx="2810739" cy="19975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07" name="Prism 9" r:id="rId3" imgW="5554013" imgH="3947288" progId="Prism9.Document">
                  <p:embed/>
                </p:oleObj>
              </mc:Choice>
              <mc:Fallback>
                <p:oleObj name="Prism 9" r:id="rId3" imgW="5554013" imgH="3947288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DF14EA5C-B55A-49BE-99D3-6F79B58A7D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2275" y="3252802"/>
                        <a:ext cx="2810739" cy="19975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96BCDF34-D189-4A83-B3DE-B6CE4C438A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3407320"/>
              </p:ext>
            </p:extLst>
          </p:nvPr>
        </p:nvGraphicFramePr>
        <p:xfrm>
          <a:off x="3582988" y="3251389"/>
          <a:ext cx="2851679" cy="1998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08" name="Prism 9" r:id="rId5" imgW="5608754" imgH="3930721" progId="Prism9.Document">
                  <p:embed/>
                </p:oleObj>
              </mc:Choice>
              <mc:Fallback>
                <p:oleObj name="Prism 9" r:id="rId5" imgW="5608754" imgH="3930721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96BCDF34-D189-4A83-B3DE-B6CE4C438A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82988" y="3251389"/>
                        <a:ext cx="2851679" cy="1998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CC192F8F-7718-4E8E-9615-AB54B76C34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0041087"/>
              </p:ext>
            </p:extLst>
          </p:nvPr>
        </p:nvGraphicFramePr>
        <p:xfrm>
          <a:off x="422275" y="5525937"/>
          <a:ext cx="2810739" cy="19707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09" name="Prism 9" r:id="rId7" imgW="5663854" imgH="3970338" progId="Prism9.Document">
                  <p:embed/>
                </p:oleObj>
              </mc:Choice>
              <mc:Fallback>
                <p:oleObj name="Prism 9" r:id="rId7" imgW="5663854" imgH="3970338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CC192F8F-7718-4E8E-9615-AB54B76C34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2275" y="5525937"/>
                        <a:ext cx="2810739" cy="19707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3A06BBC3-5E9C-435D-9301-ECCEFC0974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9190749"/>
              </p:ext>
            </p:extLst>
          </p:nvPr>
        </p:nvGraphicFramePr>
        <p:xfrm>
          <a:off x="3582989" y="5525937"/>
          <a:ext cx="2813388" cy="19707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10" name="Prism 9" r:id="rId9" imgW="5608754" imgH="3930721" progId="Prism9.Document">
                  <p:embed/>
                </p:oleObj>
              </mc:Choice>
              <mc:Fallback>
                <p:oleObj name="Prism 9" r:id="rId9" imgW="5608754" imgH="3930721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3A06BBC3-5E9C-435D-9301-ECCEFC09747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82989" y="5525937"/>
                        <a:ext cx="2813388" cy="19707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7AB5DDA4-3E90-4B3A-9318-9179AA8DF07F}"/>
              </a:ext>
            </a:extLst>
          </p:cNvPr>
          <p:cNvSpPr txBox="1"/>
          <p:nvPr/>
        </p:nvSpPr>
        <p:spPr>
          <a:xfrm>
            <a:off x="903110" y="3005828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l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B701F03-38FE-45B0-989A-8C11C978F4C6}"/>
              </a:ext>
            </a:extLst>
          </p:cNvPr>
          <p:cNvSpPr txBox="1"/>
          <p:nvPr/>
        </p:nvSpPr>
        <p:spPr>
          <a:xfrm>
            <a:off x="4058354" y="3005828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Tgfb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25E5587-F6FD-4F3B-99FA-1581532E8EBE}"/>
              </a:ext>
            </a:extLst>
          </p:cNvPr>
          <p:cNvSpPr txBox="1"/>
          <p:nvPr/>
        </p:nvSpPr>
        <p:spPr>
          <a:xfrm>
            <a:off x="903109" y="5250387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cd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DC02DE5-B1AB-420A-BB7D-496821CDB475}"/>
              </a:ext>
            </a:extLst>
          </p:cNvPr>
          <p:cNvSpPr txBox="1"/>
          <p:nvPr/>
        </p:nvSpPr>
        <p:spPr>
          <a:xfrm>
            <a:off x="4058354" y="5250387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dcd1l1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678D310-DB5A-44D4-8ADC-6D91DCFAB2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887636"/>
              </p:ext>
            </p:extLst>
          </p:nvPr>
        </p:nvGraphicFramePr>
        <p:xfrm>
          <a:off x="420688" y="796925"/>
          <a:ext cx="3103562" cy="2065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11" name="Prism 9" r:id="rId11" imgW="5909107" imgH="3930721" progId="Prism9.Document">
                  <p:embed/>
                </p:oleObj>
              </mc:Choice>
              <mc:Fallback>
                <p:oleObj name="Prism 9" r:id="rId11" imgW="5909107" imgH="3930721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7678D310-DB5A-44D4-8ADC-6D91DCFAB2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0688" y="796925"/>
                        <a:ext cx="3103562" cy="2065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02389D50-3B77-4818-95F1-4D396476C8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455743"/>
              </p:ext>
            </p:extLst>
          </p:nvPr>
        </p:nvGraphicFramePr>
        <p:xfrm>
          <a:off x="3519488" y="796925"/>
          <a:ext cx="3103562" cy="2065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12" name="Prism 9" r:id="rId13" imgW="5909107" imgH="3930721" progId="Prism9.Document">
                  <p:embed/>
                </p:oleObj>
              </mc:Choice>
              <mc:Fallback>
                <p:oleObj name="Prism 9" r:id="rId13" imgW="5909107" imgH="3930721" progId="Prism9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02389D50-3B77-4818-95F1-4D396476C8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19488" y="796925"/>
                        <a:ext cx="3103562" cy="2065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AA5ADAD6-4111-4714-A817-2FF82EBBD351}"/>
              </a:ext>
            </a:extLst>
          </p:cNvPr>
          <p:cNvSpPr txBox="1"/>
          <p:nvPr/>
        </p:nvSpPr>
        <p:spPr>
          <a:xfrm>
            <a:off x="903110" y="550705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l27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03B99FA-6665-45FD-99D8-BD80E183E5B9}"/>
              </a:ext>
            </a:extLst>
          </p:cNvPr>
          <p:cNvSpPr txBox="1"/>
          <p:nvPr/>
        </p:nvSpPr>
        <p:spPr>
          <a:xfrm>
            <a:off x="4058354" y="550705"/>
            <a:ext cx="11401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l12b</a:t>
            </a:r>
          </a:p>
        </p:txBody>
      </p:sp>
    </p:spTree>
    <p:extLst>
      <p:ext uri="{BB962C8B-B14F-4D97-AF65-F5344CB8AC3E}">
        <p14:creationId xmlns:p14="http://schemas.microsoft.com/office/powerpoint/2010/main" val="2993504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042560E-0687-48FD-8CA2-D7C428EFBDEC}"/>
              </a:ext>
            </a:extLst>
          </p:cNvPr>
          <p:cNvSpPr txBox="1"/>
          <p:nvPr/>
        </p:nvSpPr>
        <p:spPr>
          <a:xfrm>
            <a:off x="245125" y="7995076"/>
            <a:ext cx="63677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mune profiling of non-tumor bearing MD4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e/+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yd88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/Fl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 A) Frequencies of indicated immune populations isolated from spleens of healthy non-tumor bearing mice. B.) Frequencies of indicated B cell subsets isolated form spleens of healthy non-tumor bearing mice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EB55245-F7D7-4E6B-9DDE-B12E84A2DD65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1C8BB05-4270-412C-92DC-DC46AD353CC0}"/>
              </a:ext>
            </a:extLst>
          </p:cNvPr>
          <p:cNvSpPr txBox="1"/>
          <p:nvPr/>
        </p:nvSpPr>
        <p:spPr>
          <a:xfrm>
            <a:off x="198304" y="315705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aphicFrame>
        <p:nvGraphicFramePr>
          <p:cNvPr id="62" name="Object 61">
            <a:extLst>
              <a:ext uri="{FF2B5EF4-FFF2-40B4-BE49-F238E27FC236}">
                <a16:creationId xmlns:a16="http://schemas.microsoft.com/office/drawing/2014/main" id="{0A9C2C9C-A96D-4190-A651-A4F9AD00C4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4158130"/>
              </p:ext>
            </p:extLst>
          </p:nvPr>
        </p:nvGraphicFramePr>
        <p:xfrm>
          <a:off x="476736" y="733425"/>
          <a:ext cx="4248150" cy="2424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5" name="Prism 9" r:id="rId3" imgW="7112320" imgH="4057135" progId="Prism9.Document">
                  <p:embed/>
                </p:oleObj>
              </mc:Choice>
              <mc:Fallback>
                <p:oleObj name="Prism 9" r:id="rId3" imgW="7112320" imgH="4057135" progId="Prism9.Document">
                  <p:embed/>
                  <p:pic>
                    <p:nvPicPr>
                      <p:cNvPr id="62" name="Object 61">
                        <a:extLst>
                          <a:ext uri="{FF2B5EF4-FFF2-40B4-BE49-F238E27FC236}">
                            <a16:creationId xmlns:a16="http://schemas.microsoft.com/office/drawing/2014/main" id="{0A9C2C9C-A96D-4190-A651-A4F9AD00C4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736" y="733425"/>
                        <a:ext cx="4248150" cy="2424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4" name="Object 63">
            <a:extLst>
              <a:ext uri="{FF2B5EF4-FFF2-40B4-BE49-F238E27FC236}">
                <a16:creationId xmlns:a16="http://schemas.microsoft.com/office/drawing/2014/main" id="{203ECC60-6BC8-43CD-BE98-3DFA589B95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6518885"/>
              </p:ext>
            </p:extLst>
          </p:nvPr>
        </p:nvGraphicFramePr>
        <p:xfrm>
          <a:off x="476736" y="3287836"/>
          <a:ext cx="4248150" cy="2746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6" name="Prism 9" r:id="rId5" imgW="7162379" imgH="4631941" progId="Prism9.Document">
                  <p:embed/>
                </p:oleObj>
              </mc:Choice>
              <mc:Fallback>
                <p:oleObj name="Prism 9" r:id="rId5" imgW="7162379" imgH="4631941" progId="Prism9.Document">
                  <p:embed/>
                  <p:pic>
                    <p:nvPicPr>
                      <p:cNvPr id="64" name="Object 63">
                        <a:extLst>
                          <a:ext uri="{FF2B5EF4-FFF2-40B4-BE49-F238E27FC236}">
                            <a16:creationId xmlns:a16="http://schemas.microsoft.com/office/drawing/2014/main" id="{203ECC60-6BC8-43CD-BE98-3DFA589B950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6736" y="3287836"/>
                        <a:ext cx="4248150" cy="2746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476998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BBE27B9-55FE-4268-BA8E-79B09CACA066}"/>
              </a:ext>
            </a:extLst>
          </p:cNvPr>
          <p:cNvSpPr txBox="1"/>
          <p:nvPr/>
        </p:nvSpPr>
        <p:spPr>
          <a:xfrm>
            <a:off x="245125" y="7718077"/>
            <a:ext cx="636774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3. Tumor-bearing MD4 mice display decreased 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gulatory B cell function and in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reased effector T cell function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A) Representative flow cytometry plots of tumoral B cells stained for IL-35 (p35) and IL-10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 Representative flow cytometry plots of tumoral T cells stained for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TNF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FOXP3. C) Representative flow cytometry plots of splenic T cells stained for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NF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D) Representative flow cytometry plots of tumor-draining lymph node T cells stained for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FNy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NF</a:t>
            </a:r>
            <a:r>
              <a:rPr lang="el-GR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F615AF0-EE59-4498-A453-047349035F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6539" y="3095368"/>
            <a:ext cx="2492796" cy="190246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A3AD446-C965-428B-B899-3EE01C31BC5F}"/>
              </a:ext>
            </a:extLst>
          </p:cNvPr>
          <p:cNvSpPr txBox="1"/>
          <p:nvPr/>
        </p:nvSpPr>
        <p:spPr>
          <a:xfrm>
            <a:off x="245125" y="435628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4A85BB1-A31B-4CB1-B96A-73560E9E6417}"/>
              </a:ext>
            </a:extLst>
          </p:cNvPr>
          <p:cNvSpPr txBox="1"/>
          <p:nvPr/>
        </p:nvSpPr>
        <p:spPr>
          <a:xfrm>
            <a:off x="3054425" y="435628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9355736-7479-4B97-A1AB-FFA1BDE94472}"/>
              </a:ext>
            </a:extLst>
          </p:cNvPr>
          <p:cNvSpPr txBox="1"/>
          <p:nvPr/>
        </p:nvSpPr>
        <p:spPr>
          <a:xfrm>
            <a:off x="245125" y="3083779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5EB1BA-6D75-4834-9729-8EEC32FBBF89}"/>
              </a:ext>
            </a:extLst>
          </p:cNvPr>
          <p:cNvSpPr txBox="1"/>
          <p:nvPr/>
        </p:nvSpPr>
        <p:spPr>
          <a:xfrm>
            <a:off x="241156" y="4873227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038FC27-B5A9-4CEF-9EF6-3AF6C299F6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01500" y="5009419"/>
            <a:ext cx="2487835" cy="190246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1C1451EC-2073-432E-B00C-CFDED9BAEB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073" y="3132361"/>
            <a:ext cx="2483239" cy="1865469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6DE28F7-B3B4-4E4C-A0DA-1472A85C2A5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6012" y="5042309"/>
            <a:ext cx="2483240" cy="1864865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B73D055-8CCD-45A4-8BEC-249E91D0A72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9000" y="584715"/>
            <a:ext cx="2356170" cy="2499064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DAC125BC-0058-44F0-A16A-4C371CD66B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9565" y="627453"/>
            <a:ext cx="2356170" cy="1700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30060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extBox 81">
            <a:extLst>
              <a:ext uri="{FF2B5EF4-FFF2-40B4-BE49-F238E27FC236}">
                <a16:creationId xmlns:a16="http://schemas.microsoft.com/office/drawing/2014/main" id="{8EB55245-F7D7-4E6B-9DDE-B12E84A2DD65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B12877B-65D1-4587-A7C9-FD90FFEAABAF}"/>
              </a:ext>
            </a:extLst>
          </p:cNvPr>
          <p:cNvSpPr txBox="1"/>
          <p:nvPr/>
        </p:nvSpPr>
        <p:spPr>
          <a:xfrm>
            <a:off x="245125" y="7995076"/>
            <a:ext cx="63677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related to inhibition screen in Figure 4. A) Western blots of WT splenic B cells incubated with indicated inhibitor for 30 minutes prior to stimulation with αIgM (10µg/mL). 40ug of total protein loaded per lane. (B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ive CD19+ c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ll numbers associated with Figures 4A-D. N=3. (C) Fold change in B cell numbers from (B) compared to DMSO for each stimulation condition. N-=3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4AA2535-F8AB-48ED-84CB-D8FEFE280B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591" y="676489"/>
            <a:ext cx="5627760" cy="201983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25612FC-3312-4A2B-81D3-262CFC0B33E7}"/>
              </a:ext>
            </a:extLst>
          </p:cNvPr>
          <p:cNvSpPr txBox="1"/>
          <p:nvPr/>
        </p:nvSpPr>
        <p:spPr>
          <a:xfrm>
            <a:off x="198304" y="2834822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BB7834-BA0D-4B25-B990-528A55DFFC4C}"/>
              </a:ext>
            </a:extLst>
          </p:cNvPr>
          <p:cNvSpPr txBox="1"/>
          <p:nvPr/>
        </p:nvSpPr>
        <p:spPr>
          <a:xfrm>
            <a:off x="198304" y="5074179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791180D0-87B5-4654-B3DE-36C58EF73B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9952676"/>
              </p:ext>
            </p:extLst>
          </p:nvPr>
        </p:nvGraphicFramePr>
        <p:xfrm>
          <a:off x="2937442" y="5066336"/>
          <a:ext cx="3829333" cy="2285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9" name="Prism 9" r:id="rId4" imgW="6610651" imgH="3944407" progId="Prism9.Document">
                  <p:embed/>
                </p:oleObj>
              </mc:Choice>
              <mc:Fallback>
                <p:oleObj name="Prism 9" r:id="rId4" imgW="6610651" imgH="3944407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791180D0-87B5-4654-B3DE-36C58EF73B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937442" y="5066336"/>
                        <a:ext cx="3829333" cy="2285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F2A9D50C-E7CF-455A-A222-AF42659398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483" y="5159265"/>
            <a:ext cx="2420888" cy="1580988"/>
          </a:xfrm>
          <a:prstGeom prst="rect">
            <a:avLst/>
          </a:prstGeom>
        </p:spPr>
      </p:pic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C6EE2DC-AC38-472B-9FB5-1EF604D24A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7008349"/>
              </p:ext>
            </p:extLst>
          </p:nvPr>
        </p:nvGraphicFramePr>
        <p:xfrm>
          <a:off x="2782757" y="2851410"/>
          <a:ext cx="3984018" cy="2285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20" name="Prism 9" r:id="rId7" imgW="6878952" imgH="3944407" progId="Prism9.Document">
                  <p:embed/>
                </p:oleObj>
              </mc:Choice>
              <mc:Fallback>
                <p:oleObj name="Prism 9" r:id="rId7" imgW="6878952" imgH="3944407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BC6EE2DC-AC38-472B-9FB5-1EF604D24A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782757" y="2851410"/>
                        <a:ext cx="3984018" cy="2285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FBC3799B-981F-4427-AB4F-FC34EE85661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2482" y="2926064"/>
            <a:ext cx="2420889" cy="15084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5078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476C86F-7401-43A8-BF8F-03ADD3E340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9476857"/>
              </p:ext>
            </p:extLst>
          </p:nvPr>
        </p:nvGraphicFramePr>
        <p:xfrm>
          <a:off x="3429001" y="2209846"/>
          <a:ext cx="2439814" cy="15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68" name="Prism 9" r:id="rId3" imgW="6320742" imgH="3944407" progId="Prism9.Document">
                  <p:embed/>
                </p:oleObj>
              </mc:Choice>
              <mc:Fallback>
                <p:oleObj name="Prism 9" r:id="rId3" imgW="6320742" imgH="3944407" progId="Prism9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476C86F-7401-43A8-BF8F-03ADD3E340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29001" y="2209846"/>
                        <a:ext cx="2439814" cy="15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9B9B23D-6909-4DDA-A0DE-324D4AFFB3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1813388"/>
              </p:ext>
            </p:extLst>
          </p:nvPr>
        </p:nvGraphicFramePr>
        <p:xfrm>
          <a:off x="3429001" y="3732433"/>
          <a:ext cx="2439814" cy="15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69" name="Prism 9" r:id="rId5" imgW="6320742" imgH="3944407" progId="Prism9.Document">
                  <p:embed/>
                </p:oleObj>
              </mc:Choice>
              <mc:Fallback>
                <p:oleObj name="Prism 9" r:id="rId5" imgW="6320742" imgH="3944407" progId="Prism9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9B9B23D-6909-4DDA-A0DE-324D4AFFB3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1" y="3732433"/>
                        <a:ext cx="2439814" cy="15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22C450B-E479-426A-810C-D9D2D81512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0292269"/>
              </p:ext>
            </p:extLst>
          </p:nvPr>
        </p:nvGraphicFramePr>
        <p:xfrm>
          <a:off x="427495" y="5255020"/>
          <a:ext cx="2439814" cy="15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0" name="Prism 9" r:id="rId7" imgW="6320742" imgH="3944407" progId="Prism9.Document">
                  <p:embed/>
                </p:oleObj>
              </mc:Choice>
              <mc:Fallback>
                <p:oleObj name="Prism 9" r:id="rId7" imgW="6320742" imgH="3944407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E22C450B-E479-426A-810C-D9D2D815125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27495" y="5255020"/>
                        <a:ext cx="2439814" cy="15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7DB9EFC-5F24-4723-B498-E0F5802A89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2320822"/>
              </p:ext>
            </p:extLst>
          </p:nvPr>
        </p:nvGraphicFramePr>
        <p:xfrm>
          <a:off x="427494" y="3732433"/>
          <a:ext cx="2439815" cy="15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1" name="Prism 9" r:id="rId9" imgW="6320742" imgH="3944407" progId="Prism9.Document">
                  <p:embed/>
                </p:oleObj>
              </mc:Choice>
              <mc:Fallback>
                <p:oleObj name="Prism 9" r:id="rId9" imgW="6320742" imgH="3944407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57DB9EFC-5F24-4723-B498-E0F5802A89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27494" y="3732433"/>
                        <a:ext cx="2439815" cy="15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E05324F6-AF1E-4B21-B7D5-95F126DD6B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7897116"/>
              </p:ext>
            </p:extLst>
          </p:nvPr>
        </p:nvGraphicFramePr>
        <p:xfrm>
          <a:off x="427493" y="2209846"/>
          <a:ext cx="2439816" cy="152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2" name="Prism 9" r:id="rId11" imgW="6320742" imgH="3944407" progId="Prism9.Document">
                  <p:embed/>
                </p:oleObj>
              </mc:Choice>
              <mc:Fallback>
                <p:oleObj name="Prism 9" r:id="rId11" imgW="6320742" imgH="3944407" progId="Prism9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E05324F6-AF1E-4B21-B7D5-95F126DD6B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27493" y="2209846"/>
                        <a:ext cx="2439816" cy="152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41EB5A6-30C8-4E5A-AFC8-EB1AB0A711B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6664743"/>
              </p:ext>
            </p:extLst>
          </p:nvPr>
        </p:nvGraphicFramePr>
        <p:xfrm>
          <a:off x="427495" y="675414"/>
          <a:ext cx="2439814" cy="1522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3" name="Prism 9" r:id="rId13" imgW="6320742" imgH="3944407" progId="Prism9.Document">
                  <p:embed/>
                </p:oleObj>
              </mc:Choice>
              <mc:Fallback>
                <p:oleObj name="Prism 9" r:id="rId13" imgW="6320742" imgH="3944407" progId="Prism9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041EB5A6-30C8-4E5A-AFC8-EB1AB0A711B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27495" y="675414"/>
                        <a:ext cx="2439814" cy="1522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F4F285A-BA5B-4172-BA62-E5CE7454A0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9154070"/>
              </p:ext>
            </p:extLst>
          </p:nvPr>
        </p:nvGraphicFramePr>
        <p:xfrm>
          <a:off x="3428999" y="687259"/>
          <a:ext cx="2439816" cy="152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74" name="Prism 9" r:id="rId15" imgW="6320742" imgH="3944407" progId="Prism9.Document">
                  <p:embed/>
                </p:oleObj>
              </mc:Choice>
              <mc:Fallback>
                <p:oleObj name="Prism 9" r:id="rId15" imgW="6320742" imgH="3944407" progId="Prism9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0F4F285A-BA5B-4172-BA62-E5CE7454A0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28999" y="687259"/>
                        <a:ext cx="2439816" cy="152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19B6E563-D493-41E9-91B3-1EA89E9575AF}"/>
              </a:ext>
            </a:extLst>
          </p:cNvPr>
          <p:cNvSpPr txBox="1"/>
          <p:nvPr/>
        </p:nvSpPr>
        <p:spPr>
          <a:xfrm>
            <a:off x="198302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35A1FD-DCCE-4EC0-8A4F-969E8FA22125}"/>
              </a:ext>
            </a:extLst>
          </p:cNvPr>
          <p:cNvSpPr txBox="1"/>
          <p:nvPr/>
        </p:nvSpPr>
        <p:spPr>
          <a:xfrm>
            <a:off x="198302" y="2096619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4C29DB1-CA5A-453D-A133-5B06E267D6E6}"/>
              </a:ext>
            </a:extLst>
          </p:cNvPr>
          <p:cNvSpPr txBox="1"/>
          <p:nvPr/>
        </p:nvSpPr>
        <p:spPr>
          <a:xfrm>
            <a:off x="198302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DA73308-821F-4542-A702-62173C6F6705}"/>
              </a:ext>
            </a:extLst>
          </p:cNvPr>
          <p:cNvSpPr txBox="1"/>
          <p:nvPr/>
        </p:nvSpPr>
        <p:spPr>
          <a:xfrm>
            <a:off x="198302" y="504103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5F5732-C534-4413-A01C-5B33E0D5092B}"/>
              </a:ext>
            </a:extLst>
          </p:cNvPr>
          <p:cNvSpPr txBox="1"/>
          <p:nvPr/>
        </p:nvSpPr>
        <p:spPr>
          <a:xfrm>
            <a:off x="3149995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E9D33F-14F9-4B5D-A7B0-DFCE205F974C}"/>
              </a:ext>
            </a:extLst>
          </p:cNvPr>
          <p:cNvSpPr txBox="1"/>
          <p:nvPr/>
        </p:nvSpPr>
        <p:spPr>
          <a:xfrm>
            <a:off x="3148927" y="2102142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74FC3D8-740E-477E-8352-0E7D76D3721F}"/>
              </a:ext>
            </a:extLst>
          </p:cNvPr>
          <p:cNvSpPr txBox="1"/>
          <p:nvPr/>
        </p:nvSpPr>
        <p:spPr>
          <a:xfrm>
            <a:off x="3148927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2711F09-A4D3-41BB-A097-43AA3FDFA59A}"/>
              </a:ext>
            </a:extLst>
          </p:cNvPr>
          <p:cNvSpPr txBox="1"/>
          <p:nvPr/>
        </p:nvSpPr>
        <p:spPr>
          <a:xfrm>
            <a:off x="245125" y="7995076"/>
            <a:ext cx="6367749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5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Extended IL-35 reporter screen data.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A-G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Frequencies of </a:t>
            </a:r>
            <a:r>
              <a:rPr lang="en-US" sz="1200" dirty="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GFP</a:t>
            </a:r>
            <a:r>
              <a:rPr lang="en-US" sz="1200" baseline="30000" dirty="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 err="1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TdTomato</a:t>
            </a:r>
            <a:r>
              <a:rPr lang="en-US" sz="1200" baseline="300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 B cells 48 hours after stimulation with DMSO or indicated inhibitor.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10108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0579DEB0-FD2C-42F1-B0BE-54EBAADB0D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551337"/>
              </p:ext>
            </p:extLst>
          </p:nvPr>
        </p:nvGraphicFramePr>
        <p:xfrm>
          <a:off x="3428999" y="2163899"/>
          <a:ext cx="2452219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2" name="Prism 9" r:id="rId3" imgW="6270683" imgH="4058576" progId="Prism9.Document">
                  <p:embed/>
                </p:oleObj>
              </mc:Choice>
              <mc:Fallback>
                <p:oleObj name="Prism 9" r:id="rId3" imgW="6270683" imgH="4058576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0579DEB0-FD2C-42F1-B0BE-54EBAADB0D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28999" y="2163899"/>
                        <a:ext cx="2452219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F915ADFC-8ADE-4CB6-9300-2120AFCBE9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273014"/>
              </p:ext>
            </p:extLst>
          </p:nvPr>
        </p:nvGraphicFramePr>
        <p:xfrm>
          <a:off x="3428999" y="3751323"/>
          <a:ext cx="2452219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3" name="Prism 9" r:id="rId5" imgW="6270683" imgH="4058576" progId="Prism9.Document">
                  <p:embed/>
                </p:oleObj>
              </mc:Choice>
              <mc:Fallback>
                <p:oleObj name="Prism 9" r:id="rId5" imgW="6270683" imgH="4058576" progId="Prism9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F915ADFC-8ADE-4CB6-9300-2120AFCBE96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8999" y="3751323"/>
                        <a:ext cx="2452219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>
            <a:extLst>
              <a:ext uri="{FF2B5EF4-FFF2-40B4-BE49-F238E27FC236}">
                <a16:creationId xmlns:a16="http://schemas.microsoft.com/office/drawing/2014/main" id="{BB815BE9-5D3F-4681-A8C7-A7BEC005B0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5084702"/>
              </p:ext>
            </p:extLst>
          </p:nvPr>
        </p:nvGraphicFramePr>
        <p:xfrm>
          <a:off x="391153" y="5318029"/>
          <a:ext cx="2452219" cy="1513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4" name="Prism 9" r:id="rId7" imgW="6389528" imgH="3944407" progId="Prism9.Document">
                  <p:embed/>
                </p:oleObj>
              </mc:Choice>
              <mc:Fallback>
                <p:oleObj name="Prism 9" r:id="rId7" imgW="6389528" imgH="3944407" progId="Prism9.Document">
                  <p:embed/>
                  <p:pic>
                    <p:nvPicPr>
                      <p:cNvPr id="44" name="Object 43">
                        <a:extLst>
                          <a:ext uri="{FF2B5EF4-FFF2-40B4-BE49-F238E27FC236}">
                            <a16:creationId xmlns:a16="http://schemas.microsoft.com/office/drawing/2014/main" id="{BB815BE9-5D3F-4681-A8C7-A7BEC005B0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91153" y="5318029"/>
                        <a:ext cx="2452219" cy="15139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>
            <a:extLst>
              <a:ext uri="{FF2B5EF4-FFF2-40B4-BE49-F238E27FC236}">
                <a16:creationId xmlns:a16="http://schemas.microsoft.com/office/drawing/2014/main" id="{46D19F27-BCC1-40F1-8EEF-5711A07776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6286061"/>
              </p:ext>
            </p:extLst>
          </p:nvPr>
        </p:nvGraphicFramePr>
        <p:xfrm>
          <a:off x="391153" y="3751323"/>
          <a:ext cx="2452219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5" name="Prism 9" r:id="rId9" imgW="6270683" imgH="4058576" progId="Prism9.Document">
                  <p:embed/>
                </p:oleObj>
              </mc:Choice>
              <mc:Fallback>
                <p:oleObj name="Prism 9" r:id="rId9" imgW="6270683" imgH="4058576" progId="Prism9.Document">
                  <p:embed/>
                  <p:pic>
                    <p:nvPicPr>
                      <p:cNvPr id="45" name="Object 44">
                        <a:extLst>
                          <a:ext uri="{FF2B5EF4-FFF2-40B4-BE49-F238E27FC236}">
                            <a16:creationId xmlns:a16="http://schemas.microsoft.com/office/drawing/2014/main" id="{46D19F27-BCC1-40F1-8EEF-5711A07776B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1153" y="3751323"/>
                        <a:ext cx="2452219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>
            <a:extLst>
              <a:ext uri="{FF2B5EF4-FFF2-40B4-BE49-F238E27FC236}">
                <a16:creationId xmlns:a16="http://schemas.microsoft.com/office/drawing/2014/main" id="{6609390D-46E8-4D24-BBE9-B6EB9DC03E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3539178"/>
              </p:ext>
            </p:extLst>
          </p:nvPr>
        </p:nvGraphicFramePr>
        <p:xfrm>
          <a:off x="391153" y="2163899"/>
          <a:ext cx="2452219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6" name="Prism 9" r:id="rId11" imgW="6270683" imgH="4058576" progId="Prism9.Document">
                  <p:embed/>
                </p:oleObj>
              </mc:Choice>
              <mc:Fallback>
                <p:oleObj name="Prism 9" r:id="rId11" imgW="6270683" imgH="4058576" progId="Prism9.Document">
                  <p:embed/>
                  <p:pic>
                    <p:nvPicPr>
                      <p:cNvPr id="46" name="Object 45">
                        <a:extLst>
                          <a:ext uri="{FF2B5EF4-FFF2-40B4-BE49-F238E27FC236}">
                            <a16:creationId xmlns:a16="http://schemas.microsoft.com/office/drawing/2014/main" id="{6609390D-46E8-4D24-BBE9-B6EB9DC03E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91153" y="2163899"/>
                        <a:ext cx="2452219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>
            <a:extLst>
              <a:ext uri="{FF2B5EF4-FFF2-40B4-BE49-F238E27FC236}">
                <a16:creationId xmlns:a16="http://schemas.microsoft.com/office/drawing/2014/main" id="{7895C168-EFFA-420D-B12B-206C83FFD3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0632124"/>
              </p:ext>
            </p:extLst>
          </p:nvPr>
        </p:nvGraphicFramePr>
        <p:xfrm>
          <a:off x="391152" y="603082"/>
          <a:ext cx="2452220" cy="158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7" name="Prism 9" r:id="rId13" imgW="6270683" imgH="4058576" progId="Prism9.Document">
                  <p:embed/>
                </p:oleObj>
              </mc:Choice>
              <mc:Fallback>
                <p:oleObj name="Prism 9" r:id="rId13" imgW="6270683" imgH="4058576" progId="Prism9.Document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7895C168-EFFA-420D-B12B-206C83FFD39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1152" y="603082"/>
                        <a:ext cx="2452220" cy="1587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38937596-AF13-40AA-B4BC-2B0C2E158D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6405948"/>
              </p:ext>
            </p:extLst>
          </p:nvPr>
        </p:nvGraphicFramePr>
        <p:xfrm>
          <a:off x="3428999" y="603082"/>
          <a:ext cx="2452219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498" name="Prism 9" r:id="rId15" imgW="6270683" imgH="4058576" progId="Prism9.Document">
                  <p:embed/>
                </p:oleObj>
              </mc:Choice>
              <mc:Fallback>
                <p:oleObj name="Prism 9" r:id="rId15" imgW="6270683" imgH="4058576" progId="Prism9.Document">
                  <p:embed/>
                  <p:pic>
                    <p:nvPicPr>
                      <p:cNvPr id="48" name="Object 47">
                        <a:extLst>
                          <a:ext uri="{FF2B5EF4-FFF2-40B4-BE49-F238E27FC236}">
                            <a16:creationId xmlns:a16="http://schemas.microsoft.com/office/drawing/2014/main" id="{38937596-AF13-40AA-B4BC-2B0C2E158D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428999" y="603082"/>
                        <a:ext cx="2452219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AABC16B8-3DB9-497D-8280-D6DFAF0A3D87}"/>
              </a:ext>
            </a:extLst>
          </p:cNvPr>
          <p:cNvSpPr txBox="1"/>
          <p:nvPr/>
        </p:nvSpPr>
        <p:spPr>
          <a:xfrm>
            <a:off x="245125" y="7995076"/>
            <a:ext cx="6367749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6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Mean fluorescent intensity (MFI) of TdTomato in reporter screen.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A-G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Mean fluorescent intensity of TdTomato in B cells 48 hours after stimulation with DMSO or indicated inhibitor.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92205A9-808C-4862-B286-8BEDDBD61691}"/>
              </a:ext>
            </a:extLst>
          </p:cNvPr>
          <p:cNvSpPr txBox="1"/>
          <p:nvPr/>
        </p:nvSpPr>
        <p:spPr>
          <a:xfrm>
            <a:off x="198302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6A13288-EFFE-4A0B-BFEB-48A0BF2ACA43}"/>
              </a:ext>
            </a:extLst>
          </p:cNvPr>
          <p:cNvSpPr txBox="1"/>
          <p:nvPr/>
        </p:nvSpPr>
        <p:spPr>
          <a:xfrm>
            <a:off x="198302" y="2096619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EE1D6D5-0D58-4F2B-8E5C-A62C1EF4E743}"/>
              </a:ext>
            </a:extLst>
          </p:cNvPr>
          <p:cNvSpPr txBox="1"/>
          <p:nvPr/>
        </p:nvSpPr>
        <p:spPr>
          <a:xfrm>
            <a:off x="198302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34F8D14-C5C5-424D-B3FD-A35EEBB31ADC}"/>
              </a:ext>
            </a:extLst>
          </p:cNvPr>
          <p:cNvSpPr txBox="1"/>
          <p:nvPr/>
        </p:nvSpPr>
        <p:spPr>
          <a:xfrm>
            <a:off x="198302" y="504103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4E3A86-E37D-42A1-B3B8-78CC86C5FFCC}"/>
              </a:ext>
            </a:extLst>
          </p:cNvPr>
          <p:cNvSpPr txBox="1"/>
          <p:nvPr/>
        </p:nvSpPr>
        <p:spPr>
          <a:xfrm>
            <a:off x="3149995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4EE5606-B945-4D74-B32A-A622A00E233C}"/>
              </a:ext>
            </a:extLst>
          </p:cNvPr>
          <p:cNvSpPr txBox="1"/>
          <p:nvPr/>
        </p:nvSpPr>
        <p:spPr>
          <a:xfrm>
            <a:off x="3148927" y="2102142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4246B4E-FDA6-4F2A-981F-E329D5AEABF1}"/>
              </a:ext>
            </a:extLst>
          </p:cNvPr>
          <p:cNvSpPr txBox="1"/>
          <p:nvPr/>
        </p:nvSpPr>
        <p:spPr>
          <a:xfrm>
            <a:off x="3148927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</p:spTree>
    <p:extLst>
      <p:ext uri="{BB962C8B-B14F-4D97-AF65-F5344CB8AC3E}">
        <p14:creationId xmlns:p14="http://schemas.microsoft.com/office/powerpoint/2010/main" val="17933977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14D72235-050F-4B3C-B060-7ACBE977BF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4887153"/>
              </p:ext>
            </p:extLst>
          </p:nvPr>
        </p:nvGraphicFramePr>
        <p:xfrm>
          <a:off x="3523501" y="2146633"/>
          <a:ext cx="2439814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6" name="Prism 9" r:id="rId3" imgW="6270683" imgH="4079825" progId="Prism9.Document">
                  <p:embed/>
                </p:oleObj>
              </mc:Choice>
              <mc:Fallback>
                <p:oleObj name="Prism 9" r:id="rId3" imgW="6270683" imgH="4079825" progId="Prism9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14D72235-050F-4B3C-B060-7ACBE977BF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3501" y="2146633"/>
                        <a:ext cx="2439814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>
            <a:extLst>
              <a:ext uri="{FF2B5EF4-FFF2-40B4-BE49-F238E27FC236}">
                <a16:creationId xmlns:a16="http://schemas.microsoft.com/office/drawing/2014/main" id="{ADFC5A57-B5E4-441C-92C9-81F47C14E4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222284"/>
              </p:ext>
            </p:extLst>
          </p:nvPr>
        </p:nvGraphicFramePr>
        <p:xfrm>
          <a:off x="3523502" y="3676100"/>
          <a:ext cx="2439813" cy="15349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7" name="Prism 9" r:id="rId5" imgW="6270683" imgH="3944407" progId="Prism9.Document">
                  <p:embed/>
                </p:oleObj>
              </mc:Choice>
              <mc:Fallback>
                <p:oleObj name="Prism 9" r:id="rId5" imgW="6270683" imgH="3944407" progId="Prism9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ADFC5A57-B5E4-441C-92C9-81F47C14E4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23502" y="3676100"/>
                        <a:ext cx="2439813" cy="15349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>
            <a:extLst>
              <a:ext uri="{FF2B5EF4-FFF2-40B4-BE49-F238E27FC236}">
                <a16:creationId xmlns:a16="http://schemas.microsoft.com/office/drawing/2014/main" id="{BEF1A028-02F8-4A37-BD06-0019DD0FBE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7886435"/>
              </p:ext>
            </p:extLst>
          </p:nvPr>
        </p:nvGraphicFramePr>
        <p:xfrm>
          <a:off x="385589" y="2146633"/>
          <a:ext cx="2439814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8" name="Prism 9" r:id="rId7" imgW="6270683" imgH="4079825" progId="Prism9.Document">
                  <p:embed/>
                </p:oleObj>
              </mc:Choice>
              <mc:Fallback>
                <p:oleObj name="Prism 9" r:id="rId7" imgW="6270683" imgH="4079825" progId="Prism9.Document">
                  <p:embed/>
                  <p:pic>
                    <p:nvPicPr>
                      <p:cNvPr id="35" name="Object 34">
                        <a:extLst>
                          <a:ext uri="{FF2B5EF4-FFF2-40B4-BE49-F238E27FC236}">
                            <a16:creationId xmlns:a16="http://schemas.microsoft.com/office/drawing/2014/main" id="{BEF1A028-02F8-4A37-BD06-0019DD0FBE9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5589" y="2146633"/>
                        <a:ext cx="2439814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06695CF1-6B23-48BB-84D2-59716DCC6B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9227632"/>
              </p:ext>
            </p:extLst>
          </p:nvPr>
        </p:nvGraphicFramePr>
        <p:xfrm>
          <a:off x="385589" y="3676100"/>
          <a:ext cx="2439814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9" name="Prism 9" r:id="rId9" imgW="6270683" imgH="4079825" progId="Prism9.Document">
                  <p:embed/>
                </p:oleObj>
              </mc:Choice>
              <mc:Fallback>
                <p:oleObj name="Prism 9" r:id="rId9" imgW="6270683" imgH="4079825" progId="Prism9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06695CF1-6B23-48BB-84D2-59716DCC6B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85589" y="3676100"/>
                        <a:ext cx="2439814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2F8F671D-2AFF-4138-9DF1-4BDF9E133A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7117297"/>
              </p:ext>
            </p:extLst>
          </p:nvPr>
        </p:nvGraphicFramePr>
        <p:xfrm>
          <a:off x="385589" y="628689"/>
          <a:ext cx="2439814" cy="15349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0" name="Prism 9" r:id="rId11" imgW="6270683" imgH="3944407" progId="Prism9.Document">
                  <p:embed/>
                </p:oleObj>
              </mc:Choice>
              <mc:Fallback>
                <p:oleObj name="Prism 9" r:id="rId11" imgW="6270683" imgH="3944407" progId="Prism9.Document">
                  <p:embed/>
                  <p:pic>
                    <p:nvPicPr>
                      <p:cNvPr id="37" name="Object 36">
                        <a:extLst>
                          <a:ext uri="{FF2B5EF4-FFF2-40B4-BE49-F238E27FC236}">
                            <a16:creationId xmlns:a16="http://schemas.microsoft.com/office/drawing/2014/main" id="{2F8F671D-2AFF-4138-9DF1-4BDF9E133A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5589" y="628689"/>
                        <a:ext cx="2439814" cy="15349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6F6354B5-4C57-4AB5-8D9B-F8059ADE31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4088906"/>
              </p:ext>
            </p:extLst>
          </p:nvPr>
        </p:nvGraphicFramePr>
        <p:xfrm>
          <a:off x="3523502" y="628689"/>
          <a:ext cx="2439814" cy="1587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1" name="Prism 9" r:id="rId13" imgW="6270683" imgH="4079825" progId="Prism9.Document">
                  <p:embed/>
                </p:oleObj>
              </mc:Choice>
              <mc:Fallback>
                <p:oleObj name="Prism 9" r:id="rId13" imgW="6270683" imgH="4079825" progId="Prism9.Document">
                  <p:embed/>
                  <p:pic>
                    <p:nvPicPr>
                      <p:cNvPr id="38" name="Object 37">
                        <a:extLst>
                          <a:ext uri="{FF2B5EF4-FFF2-40B4-BE49-F238E27FC236}">
                            <a16:creationId xmlns:a16="http://schemas.microsoft.com/office/drawing/2014/main" id="{6F6354B5-4C57-4AB5-8D9B-F8059ADE31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23502" y="628689"/>
                        <a:ext cx="2439814" cy="1587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E8AC7746-ED56-4C3C-8181-71A46D7ACAB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9681713"/>
              </p:ext>
            </p:extLst>
          </p:nvPr>
        </p:nvGraphicFramePr>
        <p:xfrm>
          <a:off x="385589" y="5174988"/>
          <a:ext cx="2486141" cy="15349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2" name="Prism 9" r:id="rId15" imgW="6389528" imgH="3944407" progId="Prism9.Document">
                  <p:embed/>
                </p:oleObj>
              </mc:Choice>
              <mc:Fallback>
                <p:oleObj name="Prism 9" r:id="rId15" imgW="6389528" imgH="3944407" progId="Prism9.Document">
                  <p:embed/>
                  <p:pic>
                    <p:nvPicPr>
                      <p:cNvPr id="40" name="Object 39">
                        <a:extLst>
                          <a:ext uri="{FF2B5EF4-FFF2-40B4-BE49-F238E27FC236}">
                            <a16:creationId xmlns:a16="http://schemas.microsoft.com/office/drawing/2014/main" id="{E8AC7746-ED56-4C3C-8181-71A46D7ACAB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85589" y="5174988"/>
                        <a:ext cx="2486141" cy="15349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892820A8-7747-4ED0-9C37-085E6B9B98C9}"/>
              </a:ext>
            </a:extLst>
          </p:cNvPr>
          <p:cNvSpPr txBox="1"/>
          <p:nvPr/>
        </p:nvSpPr>
        <p:spPr>
          <a:xfrm>
            <a:off x="245125" y="7995076"/>
            <a:ext cx="6367749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7. 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Mean fluorescent intensity (MFI) of GFP in reporter screen.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A-G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Mean fluorescent intensity of GFP in B cells 48 hours after stimulation with DMSO or indicated inhibitor.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4D7AF52-4FD7-4B55-BFA5-B0BD370BAEE1}"/>
              </a:ext>
            </a:extLst>
          </p:cNvPr>
          <p:cNvSpPr txBox="1"/>
          <p:nvPr/>
        </p:nvSpPr>
        <p:spPr>
          <a:xfrm>
            <a:off x="198302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CF1EE5E-5DBA-4961-B2FF-AE4054198DEB}"/>
              </a:ext>
            </a:extLst>
          </p:cNvPr>
          <p:cNvSpPr txBox="1"/>
          <p:nvPr/>
        </p:nvSpPr>
        <p:spPr>
          <a:xfrm>
            <a:off x="198302" y="2096619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6726C80-0803-458D-979F-7BD9FBF9BA3A}"/>
              </a:ext>
            </a:extLst>
          </p:cNvPr>
          <p:cNvSpPr txBox="1"/>
          <p:nvPr/>
        </p:nvSpPr>
        <p:spPr>
          <a:xfrm>
            <a:off x="198302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31DA49E-3F27-4140-9177-E70CC0886CCA}"/>
              </a:ext>
            </a:extLst>
          </p:cNvPr>
          <p:cNvSpPr txBox="1"/>
          <p:nvPr/>
        </p:nvSpPr>
        <p:spPr>
          <a:xfrm>
            <a:off x="198302" y="504103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8083EE4-BF8C-40AD-81E6-36DC06AD649A}"/>
              </a:ext>
            </a:extLst>
          </p:cNvPr>
          <p:cNvSpPr txBox="1"/>
          <p:nvPr/>
        </p:nvSpPr>
        <p:spPr>
          <a:xfrm>
            <a:off x="3149995" y="54132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99595BE-5E08-49E6-BAD1-90FE23EC0DED}"/>
              </a:ext>
            </a:extLst>
          </p:cNvPr>
          <p:cNvSpPr txBox="1"/>
          <p:nvPr/>
        </p:nvSpPr>
        <p:spPr>
          <a:xfrm>
            <a:off x="3148927" y="2102142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8B69BB9-2DB5-4C54-852D-8B1E597A1D44}"/>
              </a:ext>
            </a:extLst>
          </p:cNvPr>
          <p:cNvSpPr txBox="1"/>
          <p:nvPr/>
        </p:nvSpPr>
        <p:spPr>
          <a:xfrm>
            <a:off x="3148927" y="3612824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</a:p>
        </p:txBody>
      </p:sp>
    </p:spTree>
    <p:extLst>
      <p:ext uri="{BB962C8B-B14F-4D97-AF65-F5344CB8AC3E}">
        <p14:creationId xmlns:p14="http://schemas.microsoft.com/office/powerpoint/2010/main" val="728826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7AA0B98-0CC1-4436-ABED-0210BAEDBF75}"/>
              </a:ext>
            </a:extLst>
          </p:cNvPr>
          <p:cNvSpPr txBox="1"/>
          <p:nvPr/>
        </p:nvSpPr>
        <p:spPr>
          <a:xfrm>
            <a:off x="245125" y="7995076"/>
            <a:ext cx="6367749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8. </a:t>
            </a:r>
            <a:r>
              <a:rPr lang="en-US" sz="1200" i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Prkd2-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707A/S711A tumor study data. (A) Measured volumes and weights of orthotopic KPC4662 tumors from WT and Prkd2-S707A/S711A mice 21 days post-tumor injection. N=5-6. (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B</a:t>
            </a:r>
            <a:r>
              <a:rPr lang="en-US" sz="1200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) Frequency of immune subsets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found in the spleens (left) tumors (right) of WT and Prkd2-S707A/S711A orthotopic tumor-bearing mice. N=5-6. 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6C9D059-5C37-4B3F-8E30-F2730F87FD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8722997"/>
              </p:ext>
            </p:extLst>
          </p:nvPr>
        </p:nvGraphicFramePr>
        <p:xfrm>
          <a:off x="1828501" y="656945"/>
          <a:ext cx="1600499" cy="23698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20" name="Prism 9" r:id="rId3" imgW="2509426" imgH="3715709" progId="Prism9.Document">
                  <p:embed/>
                </p:oleObj>
              </mc:Choice>
              <mc:Fallback>
                <p:oleObj name="Prism 9" r:id="rId3" imgW="2509426" imgH="3715709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6C9D059-5C37-4B3F-8E30-F2730F87FD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28501" y="656945"/>
                        <a:ext cx="1600499" cy="23698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605714A-E5E0-4E54-9056-3DB77B7B18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0140954"/>
              </p:ext>
            </p:extLst>
          </p:nvPr>
        </p:nvGraphicFramePr>
        <p:xfrm>
          <a:off x="348546" y="657739"/>
          <a:ext cx="1667314" cy="23698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21" name="Prism 9" r:id="rId5" imgW="2614585" imgH="3715709" progId="Prism9.Document">
                  <p:embed/>
                </p:oleObj>
              </mc:Choice>
              <mc:Fallback>
                <p:oleObj name="Prism 9" r:id="rId5" imgW="2614585" imgH="3715709" progId="Prism9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4605714A-E5E0-4E54-9056-3DB77B7B18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8546" y="657739"/>
                        <a:ext cx="1667314" cy="23698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35AB686-4AF8-4977-B41F-EC3D2B4741C1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045DEC-CC5B-42CF-BD30-8D5EAC1A4635}"/>
              </a:ext>
            </a:extLst>
          </p:cNvPr>
          <p:cNvSpPr txBox="1"/>
          <p:nvPr/>
        </p:nvSpPr>
        <p:spPr>
          <a:xfrm>
            <a:off x="198304" y="2989015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ABDD842-3482-4125-A4C1-A30E57E08D0C}"/>
              </a:ext>
            </a:extLst>
          </p:cNvPr>
          <p:cNvGrpSpPr/>
          <p:nvPr/>
        </p:nvGrpSpPr>
        <p:grpSpPr>
          <a:xfrm>
            <a:off x="385591" y="3244776"/>
            <a:ext cx="6316812" cy="2258422"/>
            <a:chOff x="385591" y="3402822"/>
            <a:chExt cx="6316812" cy="2258422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744FD122-C404-4238-B49A-61FC57CF205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15306794"/>
                </p:ext>
              </p:extLst>
            </p:nvPr>
          </p:nvGraphicFramePr>
          <p:xfrm>
            <a:off x="2859946" y="3402822"/>
            <a:ext cx="3842457" cy="224713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522" name="Prism 9" r:id="rId7" imgW="6064685" imgH="3546437" progId="Prism9.Document">
                    <p:embed/>
                  </p:oleObj>
                </mc:Choice>
                <mc:Fallback>
                  <p:oleObj name="Prism 9" r:id="rId7" imgW="6064685" imgH="3546437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744FD122-C404-4238-B49A-61FC57CF205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859946" y="3402822"/>
                          <a:ext cx="3842457" cy="224713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0E8B904-1810-4FBF-8E2D-9183D5041D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r="36628"/>
            <a:stretch/>
          </p:blipFill>
          <p:spPr>
            <a:xfrm>
              <a:off x="385591" y="3411820"/>
              <a:ext cx="2474355" cy="2249424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15F4DFA-F8CB-4282-BCD1-E2381F4097C3}"/>
              </a:ext>
            </a:extLst>
          </p:cNvPr>
          <p:cNvSpPr txBox="1"/>
          <p:nvPr/>
        </p:nvSpPr>
        <p:spPr>
          <a:xfrm>
            <a:off x="3531093" y="3063880"/>
            <a:ext cx="16554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endParaRPr lang="en-US" sz="11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59A0AE8-863B-421A-B57D-6EE3A0D66651}"/>
              </a:ext>
            </a:extLst>
          </p:cNvPr>
          <p:cNvSpPr txBox="1"/>
          <p:nvPr/>
        </p:nvSpPr>
        <p:spPr>
          <a:xfrm>
            <a:off x="973280" y="3063880"/>
            <a:ext cx="16554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34874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3DB340F-E5FA-4DBF-9DE9-54DC66065EFC}"/>
              </a:ext>
            </a:extLst>
          </p:cNvPr>
          <p:cNvSpPr txBox="1"/>
          <p:nvPr/>
        </p:nvSpPr>
        <p:spPr>
          <a:xfrm>
            <a:off x="198304" y="537990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D21D0B-12B4-4CA0-BC29-41D914B5E797}"/>
              </a:ext>
            </a:extLst>
          </p:cNvPr>
          <p:cNvSpPr txBox="1"/>
          <p:nvPr/>
        </p:nvSpPr>
        <p:spPr>
          <a:xfrm>
            <a:off x="245125" y="7995076"/>
            <a:ext cx="6367749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/>
                <a:ea typeface="Times New Roman" panose="02020603050405020304" pitchFamily="18" charset="0"/>
                <a:cs typeface="Times New Roman"/>
              </a:rPr>
              <a:t>Supplementary Figure 9. 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PKD2 function is required for full </a:t>
            </a:r>
            <a:r>
              <a:rPr lang="en-US" sz="12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IFNy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and TNFα expression by activated T cells. A) Frequencies of </a:t>
            </a:r>
            <a:r>
              <a:rPr lang="en-US" sz="12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IFNy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and TNFα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WT and </a:t>
            </a:r>
            <a:r>
              <a:rPr lang="en-US" sz="1200" i="1" dirty="0">
                <a:latin typeface="Times New Roman"/>
                <a:ea typeface="Times New Roman" panose="02020603050405020304" pitchFamily="18" charset="0"/>
                <a:cs typeface="Times New Roman"/>
              </a:rPr>
              <a:t>Prkd2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-S707A/S711A CD4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T </a:t>
            </a:r>
            <a:r>
              <a:rPr lang="en-US" sz="12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cellsafter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αCD3/αCD28 stimulation. N=5. B) Frequencies of </a:t>
            </a:r>
            <a:r>
              <a:rPr lang="en-US" sz="12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IFNy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 and TNFα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WT and </a:t>
            </a:r>
            <a:r>
              <a:rPr lang="en-US" sz="1200" i="1" dirty="0">
                <a:latin typeface="Times New Roman"/>
                <a:ea typeface="Times New Roman" panose="02020603050405020304" pitchFamily="18" charset="0"/>
                <a:cs typeface="Times New Roman"/>
              </a:rPr>
              <a:t>Prkd2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-S707A/S711A CD4</a:t>
            </a:r>
            <a:r>
              <a:rPr lang="en-US" sz="1200" baseline="30000" dirty="0">
                <a:latin typeface="Times New Roman"/>
                <a:ea typeface="Times New Roman" panose="02020603050405020304" pitchFamily="18" charset="0"/>
                <a:cs typeface="Times New Roman"/>
              </a:rPr>
              <a:t>+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T </a:t>
            </a:r>
            <a:r>
              <a:rPr lang="en-US" sz="1200" dirty="0" err="1">
                <a:latin typeface="Times New Roman"/>
                <a:ea typeface="Times New Roman" panose="02020603050405020304" pitchFamily="18" charset="0"/>
                <a:cs typeface="Times New Roman"/>
              </a:rPr>
              <a:t>cellsafter</a:t>
            </a:r>
            <a:r>
              <a:rPr lang="en-US" sz="1200" dirty="0">
                <a:latin typeface="Times New Roman"/>
                <a:ea typeface="Times New Roman" panose="02020603050405020304" pitchFamily="18" charset="0"/>
                <a:cs typeface="Times New Roman"/>
              </a:rPr>
              <a:t> αCD3/αCD28 stimulation. N=5.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23BE811A-78F5-440F-85D6-7D91977537C2}"/>
              </a:ext>
            </a:extLst>
          </p:cNvPr>
          <p:cNvGrpSpPr/>
          <p:nvPr/>
        </p:nvGrpSpPr>
        <p:grpSpPr>
          <a:xfrm>
            <a:off x="3510150" y="3931246"/>
            <a:ext cx="1293876" cy="3161515"/>
            <a:chOff x="3713038" y="442727"/>
            <a:chExt cx="1293876" cy="316151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4057AD3-FFC4-43CE-9684-C334B5DC56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36277"/>
            <a:stretch/>
          </p:blipFill>
          <p:spPr>
            <a:xfrm>
              <a:off x="3713038" y="442727"/>
              <a:ext cx="1293876" cy="1247903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7C79FD50-E1C5-4BAF-A63F-A2D5F82860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64854" y="1639806"/>
              <a:ext cx="1235964" cy="1964436"/>
            </a:xfrm>
            <a:prstGeom prst="rect">
              <a:avLst/>
            </a:prstGeom>
          </p:spPr>
        </p:pic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F0F03D46-6342-4D0E-99DF-63F413842635}"/>
              </a:ext>
            </a:extLst>
          </p:cNvPr>
          <p:cNvGrpSpPr/>
          <p:nvPr/>
        </p:nvGrpSpPr>
        <p:grpSpPr>
          <a:xfrm>
            <a:off x="3469867" y="679524"/>
            <a:ext cx="1338072" cy="3161515"/>
            <a:chOff x="4319693" y="3792112"/>
            <a:chExt cx="1338072" cy="3161515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C633C46-B060-43A9-8A1F-6369D8FAA9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b="36426"/>
            <a:stretch/>
          </p:blipFill>
          <p:spPr>
            <a:xfrm>
              <a:off x="4359976" y="3792112"/>
              <a:ext cx="1287780" cy="124790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D5325A0C-9459-42CD-93F3-384DE6BEAB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19693" y="5053199"/>
              <a:ext cx="1338072" cy="1900428"/>
            </a:xfrm>
            <a:prstGeom prst="rect">
              <a:avLst/>
            </a:prstGeom>
          </p:spPr>
        </p:pic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295F7383-A691-496B-81D2-1CDE93D6E0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2878" y="3952739"/>
            <a:ext cx="2754401" cy="2074173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2DD92B9F-8BF8-4C4B-A20E-83D0C9166D83}"/>
              </a:ext>
            </a:extLst>
          </p:cNvPr>
          <p:cNvSpPr txBox="1"/>
          <p:nvPr/>
        </p:nvSpPr>
        <p:spPr>
          <a:xfrm>
            <a:off x="198304" y="3792747"/>
            <a:ext cx="374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B5BE517-88F6-40C0-9782-EFC447021F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6087" y="679524"/>
            <a:ext cx="2754401" cy="21207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56597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59</Words>
  <Application>Microsoft Office PowerPoint</Application>
  <PresentationFormat>Letter Paper (8.5x11 in)</PresentationFormat>
  <Paragraphs>67</Paragraphs>
  <Slides>1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ud, Dan</dc:creator>
  <cp:lastModifiedBy>Megan Bond</cp:lastModifiedBy>
  <cp:revision>635</cp:revision>
  <cp:lastPrinted>2021-06-19T19:13:15Z</cp:lastPrinted>
  <dcterms:created xsi:type="dcterms:W3CDTF">2021-01-12T15:17:21Z</dcterms:created>
  <dcterms:modified xsi:type="dcterms:W3CDTF">2021-12-22T09:14:10Z</dcterms:modified>
</cp:coreProperties>
</file>